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napToObjects="1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14B1F-259B-B048-A0CD-8FC4B2BF12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3FCA10F-A142-D24F-AF11-EC7D67AF85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8CFAE3-7AD0-4A4B-9960-45B59AB1E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4E699F-0B11-464C-9DE1-92851E3DC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600CE6-E2CB-404E-8A61-8464B8885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69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A7EDD0-A4B1-6643-8FB3-5899B9603A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041D335-3051-2D47-A771-9DE065A07D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785952-D43E-3741-9293-4FE2BA13A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87471C-CC11-1B4D-9885-D7BE5236F6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E7443C-6F4B-9948-8DD1-C29F0F284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61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AD24368-65EC-AE49-B675-3293333A47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C0638F-CB98-7549-B857-40079AF7E8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F4E88C-2E4F-174B-B10D-3CA545DB4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200423-B7FC-644E-AE28-F8A15C8E9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7E7D63-E941-154E-AE71-63E914DFB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036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1DF7AE-6420-9744-9A66-6032C8B54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225E3D-0D29-6B42-91F6-B825FF00BD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455F61-3278-BF4D-9A08-D16551005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85B572-DB19-0B4E-AB73-2FF21B775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01BF6E-3C44-CF4F-944D-2F680D1DD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015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C19932-8E36-4A49-85C1-BD668FA7B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71A61F-372E-9A4F-B341-DF52D79CF9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65DFC8-9CD6-6F42-B9A6-970700B2E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525289-9D57-814E-9483-DAF906424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F69F84-E5BE-F446-BEE1-385F6268C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006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1A62CA-F5D7-C94B-9585-214935AF12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53E107C-B3BC-F54B-97CD-45E8AC6B95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96243-F519-3E4A-ACE2-C88AE4C17D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519BC2-8651-0847-AB5B-17E272F32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5A515C3-A4C7-7B46-B93C-E2B2FB7D0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AF294A2-0F8F-FF44-AA7C-E94B232AB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721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D852AE-F1E7-7F40-AA63-5921FAFC7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CF6EF6-AC27-D043-9779-2DBEE76B5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15FA411-05B4-E046-8DC8-60D8AE6F10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7E4AAB7-0A4A-1645-94FB-AF5F40827E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24C47F8-0C07-724B-8C4C-B250742D6C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A4E324D-6ADA-974D-A083-B3D1048F9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2A2E1C6-4FD0-9A45-9AFD-1D59B6CEB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816C1C1-0454-7843-937B-96ECA3ECC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242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76FB16-20B9-1743-871E-A022CCB432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E0B559B-ADED-1444-9BAE-21CF2CB4C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E6D702D-9487-DB4D-9321-9346BE2C1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16924A4-CA7A-A545-A080-23935A6EB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032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9F22653-9BF5-7545-AE0F-E93AEB676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21AE142-1C98-9E46-99E7-852F143B7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E915B69-893F-3E4A-98C5-DB7A9ADE0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717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343068-5571-AD49-9831-42B8DA8DC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46C8E9-F4C9-2249-BD91-46304D3A44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E2D2949-ED25-1A47-B241-A83B347185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43EF9AE-CBF7-FD41-BAB8-98AAF61D8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50082B-9544-794A-88B9-547D0BD89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7938B7C-7D07-1D46-9922-D27386A3F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58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F6139F-B021-134B-A925-C67DB220F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40799B4-BB90-B746-9810-69A5B57479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CDA00A0-0DC4-4B45-B3F4-BEE7FC406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F4D1CB-36F7-6B49-8114-C330CC1E2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22ED24-55FB-AD40-AB2F-6D4114EE1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10161B8-0C87-234A-9A00-AE516F5A4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267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C90E976-0AD8-D34A-9983-77A3EAFF6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754B7B5-6FD9-064C-ACC8-2E0683DBC3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7745F9-EFBB-CF4F-9BF2-75ACE4B549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EE920-3ABF-0C47-B59C-EFD7882ACC2B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CECC4C-D694-FB4F-BDF9-F16C96C4C5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3903C6-A0D0-344C-932A-4A259DA4ED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BDD26-2CAE-0747-871C-55E15FF64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262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DB5BC6E-40A5-7B4E-BCEE-2E2D0F719C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39" t="83496" r="51154" b="8658"/>
          <a:stretch/>
        </p:blipFill>
        <p:spPr>
          <a:xfrm>
            <a:off x="2360850" y="168041"/>
            <a:ext cx="7162216" cy="2143124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71FD6738-7FE0-574C-97CD-7F5A31A02B3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477" t="83432" r="50889" b="8610"/>
          <a:stretch/>
        </p:blipFill>
        <p:spPr>
          <a:xfrm>
            <a:off x="2360850" y="2747263"/>
            <a:ext cx="7162216" cy="214312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C2B75D9-F0A4-BB46-BA31-85941C0C94BD}"/>
              </a:ext>
            </a:extLst>
          </p:cNvPr>
          <p:cNvSpPr txBox="1"/>
          <p:nvPr/>
        </p:nvSpPr>
        <p:spPr>
          <a:xfrm>
            <a:off x="2360850" y="2325452"/>
            <a:ext cx="1900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No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744394B-9190-8547-A201-B08B159471AF}"/>
              </a:ext>
            </a:extLst>
          </p:cNvPr>
          <p:cNvSpPr txBox="1"/>
          <p:nvPr/>
        </p:nvSpPr>
        <p:spPr>
          <a:xfrm>
            <a:off x="2434206" y="4890327"/>
            <a:ext cx="1900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No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B83FFF0-1FF4-AD42-A7A5-1AA29E435492}"/>
              </a:ext>
            </a:extLst>
          </p:cNvPr>
          <p:cNvSpPr txBox="1"/>
          <p:nvPr/>
        </p:nvSpPr>
        <p:spPr>
          <a:xfrm>
            <a:off x="3814763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2D1995D-8A5C-5B46-990A-3E0CA5588D2A}"/>
              </a:ext>
            </a:extLst>
          </p:cNvPr>
          <p:cNvSpPr txBox="1"/>
          <p:nvPr/>
        </p:nvSpPr>
        <p:spPr>
          <a:xfrm>
            <a:off x="4261088" y="2329739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D15D9FC-D3B6-E54A-9512-458CBFE75C3A}"/>
              </a:ext>
            </a:extLst>
          </p:cNvPr>
          <p:cNvSpPr txBox="1"/>
          <p:nvPr/>
        </p:nvSpPr>
        <p:spPr>
          <a:xfrm>
            <a:off x="4735989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4C5099F-A14C-D94D-9494-1CEBCAFBF9F2}"/>
              </a:ext>
            </a:extLst>
          </p:cNvPr>
          <p:cNvSpPr txBox="1"/>
          <p:nvPr/>
        </p:nvSpPr>
        <p:spPr>
          <a:xfrm>
            <a:off x="5254388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7B3D213-4B0C-D646-88B7-FF71A2E13C50}"/>
              </a:ext>
            </a:extLst>
          </p:cNvPr>
          <p:cNvSpPr txBox="1"/>
          <p:nvPr/>
        </p:nvSpPr>
        <p:spPr>
          <a:xfrm>
            <a:off x="5752426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4B85B60-C672-4247-9D13-AB1A828446F8}"/>
              </a:ext>
            </a:extLst>
          </p:cNvPr>
          <p:cNvSpPr txBox="1"/>
          <p:nvPr/>
        </p:nvSpPr>
        <p:spPr>
          <a:xfrm>
            <a:off x="6236176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BE49386-CCE6-6F4F-8FF1-1E6BD12F0CF3}"/>
              </a:ext>
            </a:extLst>
          </p:cNvPr>
          <p:cNvSpPr txBox="1"/>
          <p:nvPr/>
        </p:nvSpPr>
        <p:spPr>
          <a:xfrm>
            <a:off x="6719926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950B0CC-442D-594C-B7EA-7851A72F1101}"/>
              </a:ext>
            </a:extLst>
          </p:cNvPr>
          <p:cNvSpPr txBox="1"/>
          <p:nvPr/>
        </p:nvSpPr>
        <p:spPr>
          <a:xfrm>
            <a:off x="7189389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9C65E83-EEE3-104C-81C8-A44330A711A8}"/>
              </a:ext>
            </a:extLst>
          </p:cNvPr>
          <p:cNvSpPr txBox="1"/>
          <p:nvPr/>
        </p:nvSpPr>
        <p:spPr>
          <a:xfrm>
            <a:off x="7681990" y="232545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A5DE999-9AD8-8743-8277-B97E3A13E3F6}"/>
              </a:ext>
            </a:extLst>
          </p:cNvPr>
          <p:cNvSpPr txBox="1"/>
          <p:nvPr/>
        </p:nvSpPr>
        <p:spPr>
          <a:xfrm>
            <a:off x="8091489" y="2325452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FC7FAD2-D61A-D346-A9FB-9976A91ACAE9}"/>
              </a:ext>
            </a:extLst>
          </p:cNvPr>
          <p:cNvSpPr txBox="1"/>
          <p:nvPr/>
        </p:nvSpPr>
        <p:spPr>
          <a:xfrm>
            <a:off x="8628300" y="2325452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D18C3BF-F374-E140-80FA-4E7A70E2ABA5}"/>
              </a:ext>
            </a:extLst>
          </p:cNvPr>
          <p:cNvSpPr txBox="1"/>
          <p:nvPr/>
        </p:nvSpPr>
        <p:spPr>
          <a:xfrm>
            <a:off x="9085178" y="2325452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8429B67-4F49-D24D-846E-043DBCDB32CE}"/>
              </a:ext>
            </a:extLst>
          </p:cNvPr>
          <p:cNvSpPr txBox="1"/>
          <p:nvPr/>
        </p:nvSpPr>
        <p:spPr>
          <a:xfrm>
            <a:off x="3814763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317789A-75B6-CC4C-8980-80AED7142E0C}"/>
              </a:ext>
            </a:extLst>
          </p:cNvPr>
          <p:cNvSpPr txBox="1"/>
          <p:nvPr/>
        </p:nvSpPr>
        <p:spPr>
          <a:xfrm>
            <a:off x="4261088" y="4894674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B105B06-EE03-C245-A6CD-E48B3187CB3B}"/>
              </a:ext>
            </a:extLst>
          </p:cNvPr>
          <p:cNvSpPr txBox="1"/>
          <p:nvPr/>
        </p:nvSpPr>
        <p:spPr>
          <a:xfrm>
            <a:off x="4791806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9F4C805-259F-DD49-B109-D8BBBEAEA952}"/>
              </a:ext>
            </a:extLst>
          </p:cNvPr>
          <p:cNvSpPr txBox="1"/>
          <p:nvPr/>
        </p:nvSpPr>
        <p:spPr>
          <a:xfrm>
            <a:off x="5254388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3ADFD28-FCA2-0D4F-ABC1-D871302FEF46}"/>
              </a:ext>
            </a:extLst>
          </p:cNvPr>
          <p:cNvSpPr txBox="1"/>
          <p:nvPr/>
        </p:nvSpPr>
        <p:spPr>
          <a:xfrm>
            <a:off x="5752426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A31B7AC-68B7-424D-8E93-E8A7E7A49271}"/>
              </a:ext>
            </a:extLst>
          </p:cNvPr>
          <p:cNvSpPr txBox="1"/>
          <p:nvPr/>
        </p:nvSpPr>
        <p:spPr>
          <a:xfrm>
            <a:off x="6236176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1DD9EC2-4183-414D-8E48-9F2F3340736D}"/>
              </a:ext>
            </a:extLst>
          </p:cNvPr>
          <p:cNvSpPr txBox="1"/>
          <p:nvPr/>
        </p:nvSpPr>
        <p:spPr>
          <a:xfrm>
            <a:off x="6719926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55EF136-DAA3-144B-BDB6-F15B28490F7F}"/>
              </a:ext>
            </a:extLst>
          </p:cNvPr>
          <p:cNvSpPr txBox="1"/>
          <p:nvPr/>
        </p:nvSpPr>
        <p:spPr>
          <a:xfrm>
            <a:off x="7189389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7D91C8E-6ED9-B749-AEBA-DA0F16285F56}"/>
              </a:ext>
            </a:extLst>
          </p:cNvPr>
          <p:cNvSpPr txBox="1"/>
          <p:nvPr/>
        </p:nvSpPr>
        <p:spPr>
          <a:xfrm>
            <a:off x="7681990" y="4890387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4E8CBEF-E6EB-B644-AE54-DAE140F96B63}"/>
              </a:ext>
            </a:extLst>
          </p:cNvPr>
          <p:cNvSpPr txBox="1"/>
          <p:nvPr/>
        </p:nvSpPr>
        <p:spPr>
          <a:xfrm>
            <a:off x="8091489" y="4890387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50A4B77-A7BE-7C46-AF23-44FC5063E6EF}"/>
              </a:ext>
            </a:extLst>
          </p:cNvPr>
          <p:cNvSpPr txBox="1"/>
          <p:nvPr/>
        </p:nvSpPr>
        <p:spPr>
          <a:xfrm>
            <a:off x="8628300" y="4890387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791F353-9D09-3A4B-87A6-1334E8DC501C}"/>
              </a:ext>
            </a:extLst>
          </p:cNvPr>
          <p:cNvSpPr txBox="1"/>
          <p:nvPr/>
        </p:nvSpPr>
        <p:spPr>
          <a:xfrm>
            <a:off x="9085178" y="4890387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261FB9B-FE05-7848-9663-422CA4FDCBDD}"/>
              </a:ext>
            </a:extLst>
          </p:cNvPr>
          <p:cNvSpPr txBox="1"/>
          <p:nvPr/>
        </p:nvSpPr>
        <p:spPr>
          <a:xfrm>
            <a:off x="9831150" y="1177305"/>
            <a:ext cx="2208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unmethylated products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BEAD6E3-3B64-C94E-ADDC-AC214F9D4F22}"/>
              </a:ext>
            </a:extLst>
          </p:cNvPr>
          <p:cNvSpPr txBox="1"/>
          <p:nvPr/>
        </p:nvSpPr>
        <p:spPr>
          <a:xfrm>
            <a:off x="9831150" y="3786167"/>
            <a:ext cx="2029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thylated products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B5F6B07C-B98A-0D48-90D1-31A416B403F3}"/>
              </a:ext>
            </a:extLst>
          </p:cNvPr>
          <p:cNvCxnSpPr/>
          <p:nvPr/>
        </p:nvCxnSpPr>
        <p:spPr>
          <a:xfrm flipH="1">
            <a:off x="9523066" y="1352247"/>
            <a:ext cx="368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F2A0CD80-A281-3145-A30D-11ED336F64C3}"/>
              </a:ext>
            </a:extLst>
          </p:cNvPr>
          <p:cNvCxnSpPr/>
          <p:nvPr/>
        </p:nvCxnSpPr>
        <p:spPr>
          <a:xfrm flipH="1">
            <a:off x="9523066" y="3948864"/>
            <a:ext cx="368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5FEC2EA-4BB7-6A48-9CA4-E3DEE7CB0106}"/>
              </a:ext>
            </a:extLst>
          </p:cNvPr>
          <p:cNvSpPr txBox="1"/>
          <p:nvPr/>
        </p:nvSpPr>
        <p:spPr>
          <a:xfrm>
            <a:off x="1485829" y="5268293"/>
            <a:ext cx="3016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hylation level (%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3877596-512C-A048-A7BF-2ED8E1F95D14}"/>
              </a:ext>
            </a:extLst>
          </p:cNvPr>
          <p:cNvSpPr txBox="1"/>
          <p:nvPr/>
        </p:nvSpPr>
        <p:spPr>
          <a:xfrm>
            <a:off x="3756977" y="5286867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CA1B046-68C0-0A45-9CBA-F103DB221BC1}"/>
              </a:ext>
            </a:extLst>
          </p:cNvPr>
          <p:cNvSpPr txBox="1"/>
          <p:nvPr/>
        </p:nvSpPr>
        <p:spPr>
          <a:xfrm>
            <a:off x="4260326" y="5286867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E8F9568-B8C9-6D4E-8843-789BD93F40A5}"/>
              </a:ext>
            </a:extLst>
          </p:cNvPr>
          <p:cNvSpPr txBox="1"/>
          <p:nvPr/>
        </p:nvSpPr>
        <p:spPr>
          <a:xfrm>
            <a:off x="4800890" y="5291214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1E32C77-0CD3-DE4E-9763-E7CED72EFCBE}"/>
              </a:ext>
            </a:extLst>
          </p:cNvPr>
          <p:cNvSpPr txBox="1"/>
          <p:nvPr/>
        </p:nvSpPr>
        <p:spPr>
          <a:xfrm>
            <a:off x="5276558" y="5291214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BCF1061-E424-EC4D-9B02-46C1DC70CCB7}"/>
              </a:ext>
            </a:extLst>
          </p:cNvPr>
          <p:cNvSpPr txBox="1"/>
          <p:nvPr/>
        </p:nvSpPr>
        <p:spPr>
          <a:xfrm>
            <a:off x="5703893" y="5286867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600B2BF-1CA2-394B-B332-FA9678C43B7D}"/>
              </a:ext>
            </a:extLst>
          </p:cNvPr>
          <p:cNvSpPr txBox="1"/>
          <p:nvPr/>
        </p:nvSpPr>
        <p:spPr>
          <a:xfrm>
            <a:off x="6250632" y="5281369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3E9E750-7D5A-4A40-A53C-5E9CB7B78B8D}"/>
              </a:ext>
            </a:extLst>
          </p:cNvPr>
          <p:cNvSpPr txBox="1"/>
          <p:nvPr/>
        </p:nvSpPr>
        <p:spPr>
          <a:xfrm>
            <a:off x="6694521" y="5280328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AEFA561-3426-D24E-9692-E6C8B7DD3833}"/>
              </a:ext>
            </a:extLst>
          </p:cNvPr>
          <p:cNvSpPr txBox="1"/>
          <p:nvPr/>
        </p:nvSpPr>
        <p:spPr>
          <a:xfrm>
            <a:off x="7212617" y="5281299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CC9F340-2756-1F49-8DEE-D9B494CD40E4}"/>
              </a:ext>
            </a:extLst>
          </p:cNvPr>
          <p:cNvSpPr txBox="1"/>
          <p:nvPr/>
        </p:nvSpPr>
        <p:spPr>
          <a:xfrm>
            <a:off x="7615900" y="5280054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E4F6654-D0C0-BB42-8D6C-33C98DE4BF03}"/>
              </a:ext>
            </a:extLst>
          </p:cNvPr>
          <p:cNvSpPr txBox="1"/>
          <p:nvPr/>
        </p:nvSpPr>
        <p:spPr>
          <a:xfrm>
            <a:off x="8163952" y="5281299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3E45A3E-F6BC-F74C-9C1A-4C191A3C58E4}"/>
              </a:ext>
            </a:extLst>
          </p:cNvPr>
          <p:cNvSpPr txBox="1"/>
          <p:nvPr/>
        </p:nvSpPr>
        <p:spPr>
          <a:xfrm>
            <a:off x="8633001" y="5281108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51F4C9A-DDC6-904A-80D4-4FD96DF76031}"/>
              </a:ext>
            </a:extLst>
          </p:cNvPr>
          <p:cNvSpPr txBox="1"/>
          <p:nvPr/>
        </p:nvSpPr>
        <p:spPr>
          <a:xfrm>
            <a:off x="9102050" y="5275633"/>
            <a:ext cx="92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27A4A5E-DFB3-D746-8ADB-36CD752E57E8}"/>
              </a:ext>
            </a:extLst>
          </p:cNvPr>
          <p:cNvSpPr txBox="1"/>
          <p:nvPr/>
        </p:nvSpPr>
        <p:spPr>
          <a:xfrm>
            <a:off x="-37008" y="5627259"/>
            <a:ext cx="38023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 (M) or unmethylation (U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5DDA582-B32D-5940-B5EA-40D2844949F3}"/>
              </a:ext>
            </a:extLst>
          </p:cNvPr>
          <p:cNvSpPr txBox="1"/>
          <p:nvPr/>
        </p:nvSpPr>
        <p:spPr>
          <a:xfrm>
            <a:off x="3760840" y="564191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264D6BA-E95C-BA4E-9A73-93AD4FCAE957}"/>
              </a:ext>
            </a:extLst>
          </p:cNvPr>
          <p:cNvSpPr txBox="1"/>
          <p:nvPr/>
        </p:nvSpPr>
        <p:spPr>
          <a:xfrm>
            <a:off x="4260759" y="5635466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065F06E-7251-2746-911B-027141D8EFC7}"/>
              </a:ext>
            </a:extLst>
          </p:cNvPr>
          <p:cNvSpPr txBox="1"/>
          <p:nvPr/>
        </p:nvSpPr>
        <p:spPr>
          <a:xfrm>
            <a:off x="4781692" y="5641912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FD333DB-274C-5247-A6F2-5B1B938E3AFB}"/>
              </a:ext>
            </a:extLst>
          </p:cNvPr>
          <p:cNvSpPr txBox="1"/>
          <p:nvPr/>
        </p:nvSpPr>
        <p:spPr>
          <a:xfrm>
            <a:off x="5243127" y="5644965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E59EA02-2313-4B44-96D7-2FE2B34B049D}"/>
              </a:ext>
            </a:extLst>
          </p:cNvPr>
          <p:cNvSpPr txBox="1"/>
          <p:nvPr/>
        </p:nvSpPr>
        <p:spPr>
          <a:xfrm>
            <a:off x="5720100" y="5639753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53634A8-6A03-6446-A455-57D72A06595D}"/>
              </a:ext>
            </a:extLst>
          </p:cNvPr>
          <p:cNvSpPr txBox="1"/>
          <p:nvPr/>
        </p:nvSpPr>
        <p:spPr>
          <a:xfrm>
            <a:off x="6213991" y="5643021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6A1A33E3-D10F-8F41-9345-FAFD1A96EDAF}"/>
              </a:ext>
            </a:extLst>
          </p:cNvPr>
          <p:cNvSpPr txBox="1"/>
          <p:nvPr/>
        </p:nvSpPr>
        <p:spPr>
          <a:xfrm>
            <a:off x="6688585" y="5643021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4DEF8FBC-34C8-244C-83EC-53DCE3B5AF93}"/>
              </a:ext>
            </a:extLst>
          </p:cNvPr>
          <p:cNvSpPr txBox="1"/>
          <p:nvPr/>
        </p:nvSpPr>
        <p:spPr>
          <a:xfrm>
            <a:off x="7187783" y="5643826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385062F-B17F-C046-B8AD-6D3DE068D266}"/>
              </a:ext>
            </a:extLst>
          </p:cNvPr>
          <p:cNvSpPr txBox="1"/>
          <p:nvPr/>
        </p:nvSpPr>
        <p:spPr>
          <a:xfrm>
            <a:off x="7656832" y="5643826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270A89F-0872-1F4A-B19E-AE8DB93E71C6}"/>
              </a:ext>
            </a:extLst>
          </p:cNvPr>
          <p:cNvSpPr txBox="1"/>
          <p:nvPr/>
        </p:nvSpPr>
        <p:spPr>
          <a:xfrm>
            <a:off x="8141277" y="5639753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7757B1B-A465-F440-9EF7-D6278AF48E5D}"/>
              </a:ext>
            </a:extLst>
          </p:cNvPr>
          <p:cNvSpPr txBox="1"/>
          <p:nvPr/>
        </p:nvSpPr>
        <p:spPr>
          <a:xfrm>
            <a:off x="8659813" y="5640807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613DB8A-4A50-FF4B-8730-9C8300B7C35E}"/>
              </a:ext>
            </a:extLst>
          </p:cNvPr>
          <p:cNvSpPr txBox="1"/>
          <p:nvPr/>
        </p:nvSpPr>
        <p:spPr>
          <a:xfrm>
            <a:off x="9127138" y="5641861"/>
            <a:ext cx="579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62E4122E-F96C-CE42-BEA4-5AC8A937118A}"/>
              </a:ext>
            </a:extLst>
          </p:cNvPr>
          <p:cNvSpPr/>
          <p:nvPr/>
        </p:nvSpPr>
        <p:spPr>
          <a:xfrm>
            <a:off x="1364370" y="6201181"/>
            <a:ext cx="1027074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2 Methylation-specific polymerase chain reactions. Upper: samples in which the unmethylated product was amplified. Lower: samples in which the methylated product was amplified.</a:t>
            </a:r>
            <a:endParaRPr lang="ja-JP" altLang="ja-JP" sz="1600" kern="10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2316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04</Words>
  <Application>Microsoft Macintosh PowerPoint</Application>
  <PresentationFormat>ワイド画面</PresentationFormat>
  <Paragraphs>5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比嘉　那優大</dc:creator>
  <cp:lastModifiedBy>比嘉　那優大</cp:lastModifiedBy>
  <cp:revision>8</cp:revision>
  <dcterms:created xsi:type="dcterms:W3CDTF">2021-12-01T05:45:50Z</dcterms:created>
  <dcterms:modified xsi:type="dcterms:W3CDTF">2022-01-24T07:36:26Z</dcterms:modified>
</cp:coreProperties>
</file>